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64" d="100"/>
          <a:sy n="64" d="100"/>
        </p:scale>
        <p:origin x="74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FD5C14-70C4-DD01-911A-4DB04D4121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8DF1F2-82C6-E9E1-5ACD-451C482203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A6269-56F3-4930-CC77-1A1D6D5B5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9A228-C878-89EC-04BA-3F718E913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E9CD60-E406-098A-52FE-4A2E426B7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04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096B2A-E9D6-9444-442C-167EFB0841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CDCB7B-E72C-0A67-2F2B-9D19358810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5274D1-7C2B-A535-870C-DE2713B45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C469A-7F27-5B41-1160-BD1C90B20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1C5F35-EF61-F019-5464-672D3024E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998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7BB59E2-FB1A-8677-FFC9-E7A6F0F6CB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8F7E04-2A80-A4CA-CCE8-9961D71C92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D35E86-E32B-844A-BA27-04C81C764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CB3914-7A66-1C07-8F3A-59E9426CD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A114D5-B94F-56B3-FC82-8CB4C3BFB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664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56D19-56E1-FD7D-6036-2F97C12AD1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8C9057-AC66-B8A1-2A84-3E49FB8CB9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05D7F7-1F41-F59A-BC06-2975D0226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A46A7A-3A8E-93F9-079C-077D086C5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1C3035-611C-B339-C327-9128CA7B7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387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F6B66B-8966-5DE7-8749-37244E3EB3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26755E-A816-0FD0-684F-AF689369F2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F1CF2E-66D8-A969-958B-F5F447215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3D7813-37EA-B970-5A11-908EDE48F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C8D5E5-C54A-2014-36C6-8170353C6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523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94F3E8-F2C3-0AE4-8582-113002C4B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FB4B95-4F60-39D7-361A-F63D6062BB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ABAFE6-EDEA-DF65-9E2C-9BD712849D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32A338-0521-EB09-F37A-5C649B70A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976BC5-0494-4159-2781-2500608CA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960834-F386-074B-DB9E-1BA922739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016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2BDD51-4C0F-1672-AD72-11F0084DFD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F0B1D6-28CF-B1DD-218A-F78942830B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3938E9-EFFB-10F1-C09C-E5D4F45EEA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7E216F-9D12-1FAA-044E-1A68100B44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4D6E1D5-6F64-3E1A-922C-4B7106695F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FD0C86-5286-C763-3C1D-9B606CBD7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0BC86D-C92A-90A7-72B2-3FF14016A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4DBBA5-071B-0DC3-697F-94D3D1DDC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084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D1FB7B-FAFE-D069-52E2-92442298DC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D3FE7D5-BE73-DE09-AAD8-9722D595C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3B87BE-3E82-29EC-A0A8-F5AA69871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CA7D59-B7EB-DB48-3661-E0F87E11C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499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AC3AD2-60ED-4291-0D18-C9B30FE7F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A0F9E23-76D8-E9E1-4183-5D95DCB27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9BD810-15C5-0B40-FBD2-7918F01AA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212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FB16E-1029-07E8-B77F-B5F6600EA7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F0328D-A9A9-F01D-3A63-B9BB9183F6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8021EB-BA27-C66F-AB06-F7598911EB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91C735-3D32-6F47-7D14-CCB75122D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EA562B-A4C5-52E6-1C32-0AEE346EA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E4C7C6-1A4A-556B-460C-A736CAFF7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187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5A768-FCE6-4286-3457-E44B04F53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F8EB03-8106-341C-AD3E-606AE254A0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EBEF36-8985-CBB9-A0C9-B5C0E0F32D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AF508D-78C4-C5C0-B33A-949FE527BA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D1E6A3-4DD7-930D-D33D-F44C3E16D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71E19C-36E6-1B99-2EE9-A0E608436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20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B826CC8-8526-074F-6182-47260E84D1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47B2F3-6C22-EBC7-13A6-BAB66E5BBA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95C786-607E-EC89-6B88-4A633EAEB7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AA16CE-EEB7-8071-8673-EC315FFED6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EB2C27-DFE0-0FF5-714D-DD364AECCB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411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2BB13-BBA3-DC6A-F8DA-848232BB7C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4346196" cy="658332"/>
          </a:xfrm>
        </p:spPr>
        <p:txBody>
          <a:bodyPr>
            <a:normAutofit/>
          </a:bodyPr>
          <a:lstStyle/>
          <a:p>
            <a:r>
              <a:rPr lang="en-US" sz="3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figure 2</a:t>
            </a:r>
            <a:endParaRPr lang="en-US" sz="30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08C481A-BD19-92D0-E955-36FACC3F07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42360" y="2038350"/>
            <a:ext cx="4907280" cy="27813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06C7143-3501-C105-FB73-D87CB3EE78FA}"/>
              </a:ext>
            </a:extLst>
          </p:cNvPr>
          <p:cNvSpPr txBox="1"/>
          <p:nvPr/>
        </p:nvSpPr>
        <p:spPr>
          <a:xfrm>
            <a:off x="629477" y="4819650"/>
            <a:ext cx="10933045" cy="13670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: Mean (SD) change from baseline in EQ-5D total</a:t>
            </a:r>
          </a:p>
          <a:p>
            <a:pPr marL="0" marR="0">
              <a:spcBef>
                <a:spcPts val="500"/>
              </a:spcBef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an (SD) change from baseline in EQ-5D total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-b)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health state score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c-d).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tients</a:t>
            </a:r>
            <a:r>
              <a:rPr lang="x-none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reated with 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55U</a:t>
            </a:r>
            <a:r>
              <a:rPr lang="x-none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nabotulinumtoxinA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eft) or 156–195U (right)</a:t>
            </a:r>
            <a:r>
              <a:rPr lang="x-none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t 4 or more visits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Q-5D,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uroQol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roup questionnaire; SD, standard deviation; U, units.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isit= administration visit. * </a:t>
            </a:r>
            <a:r>
              <a:rPr lang="en-US" sz="1200" i="1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 &lt; 0.001 paired t- test for change vs baseline. 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47202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88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Supplementary figure 2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lvamani, Amutha</dc:creator>
  <cp:lastModifiedBy>Selvamani, Amutha</cp:lastModifiedBy>
  <cp:revision>6</cp:revision>
  <dcterms:created xsi:type="dcterms:W3CDTF">2024-10-02T22:44:53Z</dcterms:created>
  <dcterms:modified xsi:type="dcterms:W3CDTF">2025-02-07T20:18:59Z</dcterms:modified>
</cp:coreProperties>
</file>